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nrique María Mateu de Antonio" userId="678ddb83-0020-4a06-85d2-928a222534ef" providerId="ADAL" clId="{50C5A4FA-62AB-4EEB-9D73-A7CFF7DF95C5}"/>
    <pc:docChg chg="modSld">
      <pc:chgData name="Enrique María Mateu de Antonio" userId="678ddb83-0020-4a06-85d2-928a222534ef" providerId="ADAL" clId="{50C5A4FA-62AB-4EEB-9D73-A7CFF7DF95C5}" dt="2025-04-07T13:42:22.054" v="5" actId="113"/>
      <pc:docMkLst>
        <pc:docMk/>
      </pc:docMkLst>
      <pc:sldChg chg="addSp modSp mod">
        <pc:chgData name="Enrique María Mateu de Antonio" userId="678ddb83-0020-4a06-85d2-928a222534ef" providerId="ADAL" clId="{50C5A4FA-62AB-4EEB-9D73-A7CFF7DF95C5}" dt="2025-04-07T13:42:22.054" v="5" actId="113"/>
        <pc:sldMkLst>
          <pc:docMk/>
          <pc:sldMk cId="123049603" sldId="256"/>
        </pc:sldMkLst>
        <pc:spChg chg="add mod">
          <ac:chgData name="Enrique María Mateu de Antonio" userId="678ddb83-0020-4a06-85d2-928a222534ef" providerId="ADAL" clId="{50C5A4FA-62AB-4EEB-9D73-A7CFF7DF95C5}" dt="2025-04-07T13:42:22.054" v="5" actId="113"/>
          <ac:spMkLst>
            <pc:docMk/>
            <pc:sldMk cId="123049603" sldId="256"/>
            <ac:spMk id="3" creationId="{AB3A55EF-106E-A51E-A274-436D5BB9CCE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633B6A37-AF62-B423-DBAF-4C24762FB0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Subtítol 2">
            <a:extLst>
              <a:ext uri="{FF2B5EF4-FFF2-40B4-BE49-F238E27FC236}">
                <a16:creationId xmlns:a16="http://schemas.microsoft.com/office/drawing/2014/main" id="{3F91282E-98AD-7E80-0CB1-FFB1505F78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/>
              <a:t>Feu clic aquí per editar l'estil de subtítols del patró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8360443E-EAC2-D69E-970F-240787BA1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94EEFBD5-967D-2DD5-9E5A-66288DEE46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A2E8ECF7-FDE5-7E3B-5EA1-28360C889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4738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6389C015-E015-ABAB-1070-66F3798FB1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38B4670F-240E-BD16-683C-CD225ACD29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EE9F7E8D-90FD-8C16-B0C0-A3535786B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4DC82FB5-04A3-EEC6-4150-97B460119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1A958FF9-BCF8-7116-61A9-801DDF3E0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42465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>
            <a:extLst>
              <a:ext uri="{FF2B5EF4-FFF2-40B4-BE49-F238E27FC236}">
                <a16:creationId xmlns:a16="http://schemas.microsoft.com/office/drawing/2014/main" id="{159974E0-C9DE-FF29-6B73-91CD321078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8DBA3A19-5E69-8C5E-837E-2052AD21A3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6283C96A-EDF2-7327-EF19-4583DCE723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C028538C-04A9-EA4D-9415-37CEC7D30F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C2F5C1FC-EE4B-6680-FAB3-C5A25FEC4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4876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75DB29CA-5F3E-F747-3517-AD5409AE7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EA56A679-9EF6-FE3C-6096-3D6C2D8AB8A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54B3057F-5047-A749-4C9E-6FF3405DC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D880433C-E472-F107-8203-7ABA0CBC4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AAD8B29A-72F6-0055-37E3-7137F1092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6292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A06266FB-4F7B-E9CA-EBB7-13536000D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A4881825-36FA-3AC0-92F6-846A4BF458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58110CD6-AFDA-1E05-68A9-1C7258098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CDA826ED-F9C8-C9D0-C91D-225F83F51F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C020632B-6FEC-2ADD-0BA3-5DD7B7D12C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8835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F78BB5A8-EE5A-F122-867F-FC9142263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36FA2DCE-760A-0104-8D07-4157C8F9BC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1B50FF33-437F-906B-CE59-F30D45A63E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1E31D0A7-D8C4-9505-88D5-ED3C7E784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FF7553E9-A70F-7E08-AFB6-CD18570DB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EE2450E1-612D-64E4-D1F1-AC962595CB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0814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478FF1F2-859D-7AC8-2F86-FA15C837D6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30BD3531-CF20-CD1C-E6FC-4AB217910C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43DC2CEE-F4F7-6E8E-CDB2-4182318714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text 4">
            <a:extLst>
              <a:ext uri="{FF2B5EF4-FFF2-40B4-BE49-F238E27FC236}">
                <a16:creationId xmlns:a16="http://schemas.microsoft.com/office/drawing/2014/main" id="{5F835D4B-5FA7-CCF1-FBA5-2B6D943C24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6" name="Contenidor de contingut 5">
            <a:extLst>
              <a:ext uri="{FF2B5EF4-FFF2-40B4-BE49-F238E27FC236}">
                <a16:creationId xmlns:a16="http://schemas.microsoft.com/office/drawing/2014/main" id="{C5F09CC2-F4B9-AD9F-5FA7-2D1924C522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7" name="Contenidor de data 6">
            <a:extLst>
              <a:ext uri="{FF2B5EF4-FFF2-40B4-BE49-F238E27FC236}">
                <a16:creationId xmlns:a16="http://schemas.microsoft.com/office/drawing/2014/main" id="{CB93DDD8-B757-F940-8335-941105295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8" name="Contenidor de peu de pàgina 7">
            <a:extLst>
              <a:ext uri="{FF2B5EF4-FFF2-40B4-BE49-F238E27FC236}">
                <a16:creationId xmlns:a16="http://schemas.microsoft.com/office/drawing/2014/main" id="{696E93D8-CFA0-B15A-0149-8C2B19BE8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Contenidor de número de diapositiva 8">
            <a:extLst>
              <a:ext uri="{FF2B5EF4-FFF2-40B4-BE49-F238E27FC236}">
                <a16:creationId xmlns:a16="http://schemas.microsoft.com/office/drawing/2014/main" id="{1D5025D9-3A17-95E6-7402-2AF91CD2D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9075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FE085028-B641-7921-462A-23138D73E5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data 2">
            <a:extLst>
              <a:ext uri="{FF2B5EF4-FFF2-40B4-BE49-F238E27FC236}">
                <a16:creationId xmlns:a16="http://schemas.microsoft.com/office/drawing/2014/main" id="{28B76232-663C-867A-825C-0BD267EF65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4" name="Contenidor de peu de pàgina 3">
            <a:extLst>
              <a:ext uri="{FF2B5EF4-FFF2-40B4-BE49-F238E27FC236}">
                <a16:creationId xmlns:a16="http://schemas.microsoft.com/office/drawing/2014/main" id="{1823C372-C8DA-4318-B391-F5AD6EDA0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Contenidor de número de diapositiva 4">
            <a:extLst>
              <a:ext uri="{FF2B5EF4-FFF2-40B4-BE49-F238E27FC236}">
                <a16:creationId xmlns:a16="http://schemas.microsoft.com/office/drawing/2014/main" id="{1A4C34D7-A9A3-F290-4554-41C73E468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91160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>
            <a:extLst>
              <a:ext uri="{FF2B5EF4-FFF2-40B4-BE49-F238E27FC236}">
                <a16:creationId xmlns:a16="http://schemas.microsoft.com/office/drawing/2014/main" id="{4099C8D1-AA99-0468-939A-D312B1C29A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3" name="Contenidor de peu de pàgina 2">
            <a:extLst>
              <a:ext uri="{FF2B5EF4-FFF2-40B4-BE49-F238E27FC236}">
                <a16:creationId xmlns:a16="http://schemas.microsoft.com/office/drawing/2014/main" id="{B3E8843C-6CB6-A02A-E380-E3AA02472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Contenidor de número de diapositiva 3">
            <a:extLst>
              <a:ext uri="{FF2B5EF4-FFF2-40B4-BE49-F238E27FC236}">
                <a16:creationId xmlns:a16="http://schemas.microsoft.com/office/drawing/2014/main" id="{531054AD-6415-46F9-80F6-475C2BB26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33543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B9978F19-92A5-9ECC-FE70-53E40AC6AF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A7F85FA0-DF61-D317-CC5F-5F73D15E36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90E8AA88-0D59-E09E-E551-3BB5181657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3587ACCB-0161-6BFA-7848-DFAF48A54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5E8A6ACF-3099-B7F8-CCE3-BD3AD3730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AD725E5A-6B3B-FBE6-9A45-A14909291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8731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7C71E860-5095-F942-096A-BC241F8BF3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'imatge 2">
            <a:extLst>
              <a:ext uri="{FF2B5EF4-FFF2-40B4-BE49-F238E27FC236}">
                <a16:creationId xmlns:a16="http://schemas.microsoft.com/office/drawing/2014/main" id="{0B767E54-4562-8769-5F91-97EBFE4EC3D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97A3DEF9-AE43-D632-CE34-A4464DF12B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A3DA0E35-1E50-5590-ACB0-34E7AF8035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CF28C04E-3795-7FD9-E5DA-CF9EADADC1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86445276-4E28-140E-E894-5580A3777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4194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>
            <a:extLst>
              <a:ext uri="{FF2B5EF4-FFF2-40B4-BE49-F238E27FC236}">
                <a16:creationId xmlns:a16="http://schemas.microsoft.com/office/drawing/2014/main" id="{A2BA993C-9F0E-7961-627D-C9D357D1EC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AF9C2AEC-3936-9678-659B-7EFD137EBE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52795D8A-C6C3-EAD9-31FD-0DD0794446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D7F4B7-F9CF-4758-BCD9-D04E3D7DD1DB}" type="datetimeFigureOut">
              <a:rPr lang="es-ES" smtClean="0"/>
              <a:t>07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B8A24378-318E-088C-363B-2DDA8EF66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C7374EB9-EA6D-2A4B-83D2-CEC924FEC3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2F1F9C-DCBB-471C-ACE1-A4B8EDF0D0B2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4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QuadreDeText 5">
            <a:extLst>
              <a:ext uri="{FF2B5EF4-FFF2-40B4-BE49-F238E27FC236}">
                <a16:creationId xmlns:a16="http://schemas.microsoft.com/office/drawing/2014/main" id="{CE4E258E-9FEC-2299-6279-C50CFFB1514B}"/>
              </a:ext>
            </a:extLst>
          </p:cNvPr>
          <p:cNvSpPr txBox="1"/>
          <p:nvPr/>
        </p:nvSpPr>
        <p:spPr>
          <a:xfrm>
            <a:off x="5153025" y="4497824"/>
            <a:ext cx="188595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12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 = -3.394*X + 38.98</a:t>
            </a:r>
          </a:p>
        </p:txBody>
      </p:sp>
      <p:graphicFrame>
        <p:nvGraphicFramePr>
          <p:cNvPr id="8" name="Objecte 7">
            <a:extLst>
              <a:ext uri="{FF2B5EF4-FFF2-40B4-BE49-F238E27FC236}">
                <a16:creationId xmlns:a16="http://schemas.microsoft.com/office/drawing/2014/main" id="{2B89AD78-2BA1-68A2-A92B-550745AB66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710899"/>
              </p:ext>
            </p:extLst>
          </p:nvPr>
        </p:nvGraphicFramePr>
        <p:xfrm>
          <a:off x="3177540" y="1914525"/>
          <a:ext cx="4794885" cy="38659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753334" imgH="3026374" progId="Prism10.Document">
                  <p:embed/>
                </p:oleObj>
              </mc:Choice>
              <mc:Fallback>
                <p:oleObj name="Prism 10" r:id="rId2" imgW="3753334" imgH="3026374" progId="Prism10.Document">
                  <p:embed/>
                  <p:pic>
                    <p:nvPicPr>
                      <p:cNvPr id="8" name="Objecte 7">
                        <a:extLst>
                          <a:ext uri="{FF2B5EF4-FFF2-40B4-BE49-F238E27FC236}">
                            <a16:creationId xmlns:a16="http://schemas.microsoft.com/office/drawing/2014/main" id="{2B89AD78-2BA1-68A2-A92B-550745AB66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77540" y="1914525"/>
                        <a:ext cx="4794885" cy="38659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QuadreDeText 2">
            <a:extLst>
              <a:ext uri="{FF2B5EF4-FFF2-40B4-BE49-F238E27FC236}">
                <a16:creationId xmlns:a16="http://schemas.microsoft.com/office/drawing/2014/main" id="{AB3A55EF-106E-A51E-A274-436D5BB9CCE0}"/>
              </a:ext>
            </a:extLst>
          </p:cNvPr>
          <p:cNvSpPr txBox="1"/>
          <p:nvPr/>
        </p:nvSpPr>
        <p:spPr>
          <a:xfrm>
            <a:off x="752474" y="431217"/>
            <a:ext cx="1023937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material 1.  </a:t>
            </a:r>
            <a:r>
              <a:rPr lang="en-US" dirty="0"/>
              <a:t>Correlation between Ct values and log10 TCID50/ml titers for R1 strain using the LSI VETMAX EUNA 2.0 kit.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230496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icin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33</Words>
  <Application>Microsoft Office PowerPoint</Application>
  <PresentationFormat>Pantalla panoràmica</PresentationFormat>
  <Paragraphs>2</Paragraphs>
  <Slides>1</Slides>
  <Notes>0</Notes>
  <HiddenSlides>0</HiddenSlides>
  <MMClips>0</MMClips>
  <ScaleCrop>false</ScaleCrop>
  <HeadingPairs>
    <vt:vector size="8" baseType="variant">
      <vt:variant>
        <vt:lpstr>Tipus de lletra utilitzats</vt:lpstr>
      </vt:variant>
      <vt:variant>
        <vt:i4>4</vt:i4>
      </vt:variant>
      <vt:variant>
        <vt:lpstr>Tema</vt:lpstr>
      </vt:variant>
      <vt:variant>
        <vt:i4>1</vt:i4>
      </vt:variant>
      <vt:variant>
        <vt:lpstr>Servidors OLE incrustats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ema de l'Office</vt:lpstr>
      <vt:lpstr>Prism 10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nrique María Mateu de Antonio</dc:creator>
  <cp:lastModifiedBy>Enrique María Mateu de Antonio</cp:lastModifiedBy>
  <cp:revision>1</cp:revision>
  <dcterms:created xsi:type="dcterms:W3CDTF">2025-02-21T15:18:34Z</dcterms:created>
  <dcterms:modified xsi:type="dcterms:W3CDTF">2025-04-07T13:42:24Z</dcterms:modified>
</cp:coreProperties>
</file>